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6281"/>
  </p:normalViewPr>
  <p:slideViewPr>
    <p:cSldViewPr snapToGrid="0">
      <p:cViewPr varScale="1">
        <p:scale>
          <a:sx n="87" d="100"/>
          <a:sy n="87" d="100"/>
        </p:scale>
        <p:origin x="2984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 dirty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 dirty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DC24E-CD13-A648-B60E-2C5587CF8B9C}" type="datetimeFigureOut">
              <a:t>12/3/25</a:t>
            </a:fld>
            <a:endParaRPr lang="en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9B3E1-ECFA-C549-A679-DB1424480AB4}" type="slidenum"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32332508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dirty="0"/>
              <a:t>Click to edit Master text styles</a:t>
            </a:r>
          </a:p>
          <a:p>
            <a:pPr lvl="1"/>
            <a:r>
              <a:rPr lang="en-GB" dirty="0"/>
              <a:t>Second level</a:t>
            </a:r>
          </a:p>
          <a:p>
            <a:pPr lvl="2"/>
            <a:r>
              <a:rPr lang="en-GB" dirty="0"/>
              <a:t>Third level</a:t>
            </a:r>
          </a:p>
          <a:p>
            <a:pPr lvl="3"/>
            <a:r>
              <a:rPr lang="en-GB" dirty="0"/>
              <a:t>Fourth level</a:t>
            </a:r>
          </a:p>
          <a:p>
            <a:pPr lvl="4"/>
            <a:r>
              <a:rPr lang="en-GB" dirty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DC24E-CD13-A648-B60E-2C5587CF8B9C}" type="datetimeFigureOut">
              <a:t>12/3/25</a:t>
            </a:fld>
            <a:endParaRPr lang="en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9B3E1-ECFA-C549-A679-DB1424480AB4}" type="slidenum"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33592395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 dirty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 dirty="0"/>
              <a:t>Click to edit Master text styles</a:t>
            </a:r>
          </a:p>
          <a:p>
            <a:pPr lvl="1"/>
            <a:r>
              <a:rPr lang="en-GB" dirty="0"/>
              <a:t>Second level</a:t>
            </a:r>
          </a:p>
          <a:p>
            <a:pPr lvl="2"/>
            <a:r>
              <a:rPr lang="en-GB" dirty="0"/>
              <a:t>Third level</a:t>
            </a:r>
          </a:p>
          <a:p>
            <a:pPr lvl="3"/>
            <a:r>
              <a:rPr lang="en-GB" dirty="0"/>
              <a:t>Fourth level</a:t>
            </a:r>
          </a:p>
          <a:p>
            <a:pPr lvl="4"/>
            <a:r>
              <a:rPr lang="en-GB" dirty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DC24E-CD13-A648-B60E-2C5587CF8B9C}" type="datetimeFigureOut">
              <a:t>12/3/25</a:t>
            </a:fld>
            <a:endParaRPr lang="en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9B3E1-ECFA-C549-A679-DB1424480AB4}" type="slidenum"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2973980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dirty="0"/>
              <a:t>Click to edit Master text styles</a:t>
            </a:r>
          </a:p>
          <a:p>
            <a:pPr lvl="1"/>
            <a:r>
              <a:rPr lang="en-GB" dirty="0"/>
              <a:t>Second level</a:t>
            </a:r>
          </a:p>
          <a:p>
            <a:pPr lvl="2"/>
            <a:r>
              <a:rPr lang="en-GB" dirty="0"/>
              <a:t>Third level</a:t>
            </a:r>
          </a:p>
          <a:p>
            <a:pPr lvl="3"/>
            <a:r>
              <a:rPr lang="en-GB" dirty="0"/>
              <a:t>Fourth level</a:t>
            </a:r>
          </a:p>
          <a:p>
            <a:pPr lvl="4"/>
            <a:r>
              <a:rPr lang="en-GB" dirty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DC24E-CD13-A648-B60E-2C5587CF8B9C}" type="datetimeFigureOut">
              <a:t>12/3/25</a:t>
            </a:fld>
            <a:endParaRPr lang="en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9B3E1-ECFA-C549-A679-DB1424480AB4}" type="slidenum"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25755537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 dirty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dirty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DC24E-CD13-A648-B60E-2C5587CF8B9C}" type="datetimeFigureOut">
              <a:t>12/3/25</a:t>
            </a:fld>
            <a:endParaRPr lang="en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9B3E1-ECFA-C549-A679-DB1424480AB4}" type="slidenum"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14759828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 dirty="0"/>
              <a:t>Click to edit Master text styles</a:t>
            </a:r>
          </a:p>
          <a:p>
            <a:pPr lvl="1"/>
            <a:r>
              <a:rPr lang="en-GB" dirty="0"/>
              <a:t>Second level</a:t>
            </a:r>
          </a:p>
          <a:p>
            <a:pPr lvl="2"/>
            <a:r>
              <a:rPr lang="en-GB" dirty="0"/>
              <a:t>Third level</a:t>
            </a:r>
          </a:p>
          <a:p>
            <a:pPr lvl="3"/>
            <a:r>
              <a:rPr lang="en-GB" dirty="0"/>
              <a:t>Fourth level</a:t>
            </a:r>
          </a:p>
          <a:p>
            <a:pPr lvl="4"/>
            <a:r>
              <a:rPr lang="en-GB" dirty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 dirty="0"/>
              <a:t>Click to edit Master text styles</a:t>
            </a:r>
          </a:p>
          <a:p>
            <a:pPr lvl="1"/>
            <a:r>
              <a:rPr lang="en-GB" dirty="0"/>
              <a:t>Second level</a:t>
            </a:r>
          </a:p>
          <a:p>
            <a:pPr lvl="2"/>
            <a:r>
              <a:rPr lang="en-GB" dirty="0"/>
              <a:t>Third level</a:t>
            </a:r>
          </a:p>
          <a:p>
            <a:pPr lvl="3"/>
            <a:r>
              <a:rPr lang="en-GB" dirty="0"/>
              <a:t>Fourth level</a:t>
            </a:r>
          </a:p>
          <a:p>
            <a:pPr lvl="4"/>
            <a:r>
              <a:rPr lang="en-GB" dirty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DC24E-CD13-A648-B60E-2C5587CF8B9C}" type="datetimeFigureOut">
              <a:t>12/3/25</a:t>
            </a:fld>
            <a:endParaRPr lang="en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9B3E1-ECFA-C549-A679-DB1424480AB4}" type="slidenum"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19097151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 dirty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 dirty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 dirty="0"/>
              <a:t>Click to edit Master text styles</a:t>
            </a:r>
          </a:p>
          <a:p>
            <a:pPr lvl="1"/>
            <a:r>
              <a:rPr lang="en-GB" dirty="0"/>
              <a:t>Second level</a:t>
            </a:r>
          </a:p>
          <a:p>
            <a:pPr lvl="2"/>
            <a:r>
              <a:rPr lang="en-GB" dirty="0"/>
              <a:t>Third level</a:t>
            </a:r>
          </a:p>
          <a:p>
            <a:pPr lvl="3"/>
            <a:r>
              <a:rPr lang="en-GB" dirty="0"/>
              <a:t>Fourth level</a:t>
            </a:r>
          </a:p>
          <a:p>
            <a:pPr lvl="4"/>
            <a:r>
              <a:rPr lang="en-GB" dirty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 dirty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 dirty="0"/>
              <a:t>Click to edit Master text styles</a:t>
            </a:r>
          </a:p>
          <a:p>
            <a:pPr lvl="1"/>
            <a:r>
              <a:rPr lang="en-GB" dirty="0"/>
              <a:t>Second level</a:t>
            </a:r>
          </a:p>
          <a:p>
            <a:pPr lvl="2"/>
            <a:r>
              <a:rPr lang="en-GB" dirty="0"/>
              <a:t>Third level</a:t>
            </a:r>
          </a:p>
          <a:p>
            <a:pPr lvl="3"/>
            <a:r>
              <a:rPr lang="en-GB" dirty="0"/>
              <a:t>Fourth level</a:t>
            </a:r>
          </a:p>
          <a:p>
            <a:pPr lvl="4"/>
            <a:r>
              <a:rPr lang="en-GB" dirty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DC24E-CD13-A648-B60E-2C5587CF8B9C}" type="datetimeFigureOut">
              <a:t>12/3/25</a:t>
            </a:fld>
            <a:endParaRPr lang="en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9B3E1-ECFA-C549-A679-DB1424480AB4}" type="slidenum"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3694426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DC24E-CD13-A648-B60E-2C5587CF8B9C}" type="datetimeFigureOut">
              <a:t>12/3/25</a:t>
            </a:fld>
            <a:endParaRPr lang="en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9B3E1-ECFA-C549-A679-DB1424480AB4}" type="slidenum"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39521939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DC24E-CD13-A648-B60E-2C5587CF8B9C}" type="datetimeFigureOut">
              <a:t>12/3/25</a:t>
            </a:fld>
            <a:endParaRPr lang="en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9B3E1-ECFA-C549-A679-DB1424480AB4}" type="slidenum"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8668153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 dirty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 dirty="0"/>
              <a:t>Click to edit Master text styles</a:t>
            </a:r>
          </a:p>
          <a:p>
            <a:pPr lvl="1"/>
            <a:r>
              <a:rPr lang="en-GB" dirty="0"/>
              <a:t>Second level</a:t>
            </a:r>
          </a:p>
          <a:p>
            <a:pPr lvl="2"/>
            <a:r>
              <a:rPr lang="en-GB" dirty="0"/>
              <a:t>Third level</a:t>
            </a:r>
          </a:p>
          <a:p>
            <a:pPr lvl="3"/>
            <a:r>
              <a:rPr lang="en-GB" dirty="0"/>
              <a:t>Fourth level</a:t>
            </a:r>
          </a:p>
          <a:p>
            <a:pPr lvl="4"/>
            <a:r>
              <a:rPr lang="en-GB" dirty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 dirty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DC24E-CD13-A648-B60E-2C5587CF8B9C}" type="datetimeFigureOut">
              <a:t>12/3/25</a:t>
            </a:fld>
            <a:endParaRPr lang="en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9B3E1-ECFA-C549-A679-DB1424480AB4}" type="slidenum"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7345654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 dirty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 dirty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 dirty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DC24E-CD13-A648-B60E-2C5587CF8B9C}" type="datetimeFigureOut">
              <a:t>12/3/25</a:t>
            </a:fld>
            <a:endParaRPr lang="en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9B3E1-ECFA-C549-A679-DB1424480AB4}" type="slidenum"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22544043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dirty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dirty="0"/>
              <a:t>Click to edit Master text styles</a:t>
            </a:r>
          </a:p>
          <a:p>
            <a:pPr lvl="1"/>
            <a:r>
              <a:rPr lang="en-GB" dirty="0"/>
              <a:t>Second level</a:t>
            </a:r>
          </a:p>
          <a:p>
            <a:pPr lvl="2"/>
            <a:r>
              <a:rPr lang="en-GB" dirty="0"/>
              <a:t>Third level</a:t>
            </a:r>
          </a:p>
          <a:p>
            <a:pPr lvl="3"/>
            <a:r>
              <a:rPr lang="en-GB" dirty="0"/>
              <a:t>Fourth level</a:t>
            </a:r>
          </a:p>
          <a:p>
            <a:pPr lvl="4"/>
            <a:r>
              <a:rPr lang="en-GB" dirty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FDC24E-CD13-A648-B60E-2C5587CF8B9C}" type="datetimeFigureOut">
              <a:t>12/3/25</a:t>
            </a:fld>
            <a:endParaRPr lang="en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99B3E1-ECFA-C549-A679-DB1424480AB4}" type="slidenum"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13634592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openxmlformats.org/officeDocument/2006/relationships/image" Target="../media/image4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jpeg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677C58A7-4292-28CD-4386-1A17E67BEE2A}"/>
              </a:ext>
            </a:extLst>
          </p:cNvPr>
          <p:cNvPicPr>
            <a:picLocks noChangeAspect="1"/>
          </p:cNvPicPr>
          <p:nvPr/>
        </p:nvPicPr>
        <p:blipFill>
          <a:blip r:embed="rId2" cstate="email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32850" y="1377097"/>
            <a:ext cx="2736000" cy="2736000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B93FC8BD-E80F-5ABF-8A95-708FF12ED5FD}"/>
              </a:ext>
            </a:extLst>
          </p:cNvPr>
          <p:cNvPicPr>
            <a:picLocks noChangeAspect="1"/>
          </p:cNvPicPr>
          <p:nvPr/>
        </p:nvPicPr>
        <p:blipFill>
          <a:blip r:embed="rId4" cstate="email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455432" y="3213097"/>
            <a:ext cx="900000" cy="900000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D6D19D02-4598-B08D-C958-F2B7545A188B}"/>
              </a:ext>
            </a:extLst>
          </p:cNvPr>
          <p:cNvPicPr>
            <a:picLocks noChangeAspect="1"/>
          </p:cNvPicPr>
          <p:nvPr/>
        </p:nvPicPr>
        <p:blipFill>
          <a:blip r:embed="rId6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726839" y="1377096"/>
            <a:ext cx="2736001" cy="2736001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0322672F-F530-DDA9-184D-897A62BE1E84}"/>
              </a:ext>
            </a:extLst>
          </p:cNvPr>
          <p:cNvPicPr>
            <a:picLocks noChangeAspect="1"/>
          </p:cNvPicPr>
          <p:nvPr/>
        </p:nvPicPr>
        <p:blipFill>
          <a:blip r:embed="rId7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548440" y="3198697"/>
            <a:ext cx="914400" cy="914400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sp>
        <p:nvSpPr>
          <p:cNvPr id="12" name="Rectángulo: esquinas redondeadas 32">
            <a:extLst>
              <a:ext uri="{FF2B5EF4-FFF2-40B4-BE49-F238E27FC236}">
                <a16:creationId xmlns:a16="http://schemas.microsoft.com/office/drawing/2014/main" id="{E0BFB949-4505-88C1-72A2-3A1F369C29A4}"/>
              </a:ext>
            </a:extLst>
          </p:cNvPr>
          <p:cNvSpPr/>
          <p:nvPr/>
        </p:nvSpPr>
        <p:spPr>
          <a:xfrm>
            <a:off x="640397" y="1377096"/>
            <a:ext cx="293660" cy="287130"/>
          </a:xfrm>
          <a:prstGeom prst="roundRect">
            <a:avLst>
              <a:gd name="adj" fmla="val 29056"/>
            </a:avLst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b="1" dirty="0">
                <a:solidFill>
                  <a:schemeClr val="bg1">
                    <a:lumMod val="9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ca-ES" b="1" dirty="0">
              <a:solidFill>
                <a:schemeClr val="bg1">
                  <a:lumMod val="95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Rectángulo: esquinas redondeadas 33">
            <a:extLst>
              <a:ext uri="{FF2B5EF4-FFF2-40B4-BE49-F238E27FC236}">
                <a16:creationId xmlns:a16="http://schemas.microsoft.com/office/drawing/2014/main" id="{FBCCFDA3-D4CB-91B0-CDCE-ACAFD5045A02}"/>
              </a:ext>
            </a:extLst>
          </p:cNvPr>
          <p:cNvSpPr/>
          <p:nvPr/>
        </p:nvSpPr>
        <p:spPr>
          <a:xfrm>
            <a:off x="3726839" y="1376850"/>
            <a:ext cx="293660" cy="287130"/>
          </a:xfrm>
          <a:prstGeom prst="roundRect">
            <a:avLst>
              <a:gd name="adj" fmla="val 29056"/>
            </a:avLst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b="1" dirty="0">
                <a:solidFill>
                  <a:schemeClr val="bg1">
                    <a:lumMod val="9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ca-ES" b="1" dirty="0">
              <a:solidFill>
                <a:schemeClr val="bg1">
                  <a:lumMod val="95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CuadroTexto 1">
            <a:extLst>
              <a:ext uri="{FF2B5EF4-FFF2-40B4-BE49-F238E27FC236}">
                <a16:creationId xmlns:a16="http://schemas.microsoft.com/office/drawing/2014/main" id="{6EE1242C-2B89-F175-F49E-8AFAA4210425}"/>
              </a:ext>
            </a:extLst>
          </p:cNvPr>
          <p:cNvSpPr txBox="1"/>
          <p:nvPr/>
        </p:nvSpPr>
        <p:spPr>
          <a:xfrm rot="10800000" flipV="1">
            <a:off x="613441" y="4314175"/>
            <a:ext cx="5843588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ca-ES" sz="1100" b="1" dirty="0"/>
              <a:t>Supplemental Figure S2</a:t>
            </a:r>
            <a:r>
              <a:rPr lang="ca-ES" sz="1100" dirty="0"/>
              <a:t>: Representative transmission electron microscopy (TEM) control images with immunogold labeling using the PdAfpB-specific antibody. Black dots indicate background gold signalling. Image A shows a leaf agroinfiltrated with the GFP construct, displaying fragments of cells with large vacuoles where no gold signalling is observed. Image B, corresponding to a non-agroinfiltrated control leaf, shows some gold particles present in the tracheoles of the Xylem within the leaf's vessels. The insets show the same regions with lower magnification.</a:t>
            </a:r>
          </a:p>
        </p:txBody>
      </p:sp>
    </p:spTree>
    <p:extLst>
      <p:ext uri="{BB962C8B-B14F-4D97-AF65-F5344CB8AC3E}">
        <p14:creationId xmlns:p14="http://schemas.microsoft.com/office/powerpoint/2010/main" val="4657808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43</TotalTime>
  <Words>91</Words>
  <Application>Microsoft Macintosh PowerPoint</Application>
  <PresentationFormat>A4 Paper (210x297 mm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an José López-Moya Gómez</dc:creator>
  <cp:lastModifiedBy>Juan José López-Moya Gómez</cp:lastModifiedBy>
  <cp:revision>5</cp:revision>
  <dcterms:created xsi:type="dcterms:W3CDTF">2025-03-04T15:38:40Z</dcterms:created>
  <dcterms:modified xsi:type="dcterms:W3CDTF">2025-03-12T10:14:11Z</dcterms:modified>
</cp:coreProperties>
</file>